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14" y="3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B1FC5-EAD5-4681-A476-C3E579FC9EC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AEE93-DC4A-45CE-8728-E81D2FFEA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8268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B1FC5-EAD5-4681-A476-C3E579FC9EC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AEE93-DC4A-45CE-8728-E81D2FFEA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23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B1FC5-EAD5-4681-A476-C3E579FC9EC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AEE93-DC4A-45CE-8728-E81D2FFEA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8706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B1FC5-EAD5-4681-A476-C3E579FC9EC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AEE93-DC4A-45CE-8728-E81D2FFEA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0364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B1FC5-EAD5-4681-A476-C3E579FC9EC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AEE93-DC4A-45CE-8728-E81D2FFEA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148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B1FC5-EAD5-4681-A476-C3E579FC9EC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AEE93-DC4A-45CE-8728-E81D2FFEA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5076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B1FC5-EAD5-4681-A476-C3E579FC9EC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AEE93-DC4A-45CE-8728-E81D2FFEA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015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B1FC5-EAD5-4681-A476-C3E579FC9EC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AEE93-DC4A-45CE-8728-E81D2FFEA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3257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B1FC5-EAD5-4681-A476-C3E579FC9EC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AEE93-DC4A-45CE-8728-E81D2FFEA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21109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B1FC5-EAD5-4681-A476-C3E579FC9EC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AEE93-DC4A-45CE-8728-E81D2FFEA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02398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3B1FC5-EAD5-4681-A476-C3E579FC9EC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AEE93-DC4A-45CE-8728-E81D2FFEA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84581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3B1FC5-EAD5-4681-A476-C3E579FC9EC5}" type="datetimeFigureOut">
              <a:rPr lang="en-US" smtClean="0"/>
              <a:t>01/0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0AEE93-DC4A-45CE-8728-E81D2FFEAD1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892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88923" y="6431086"/>
            <a:ext cx="982242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data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10. 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tein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quence alignments for </a:t>
            </a:r>
            <a:r>
              <a:rPr lang="en-US" sz="1400" b="1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cpA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strains belonging 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o lineages C and D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t="25555" r="56875" b="40494"/>
          <a:stretch/>
        </p:blipFill>
        <p:spPr>
          <a:xfrm>
            <a:off x="812805" y="0"/>
            <a:ext cx="7072622" cy="31320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/>
          <a:srcRect t="55679" r="56479" b="10370"/>
          <a:stretch/>
        </p:blipFill>
        <p:spPr>
          <a:xfrm>
            <a:off x="818495" y="3215543"/>
            <a:ext cx="7066932" cy="313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52145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CTI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gane Nennig</dc:creator>
  <cp:lastModifiedBy>Morgane Nennig</cp:lastModifiedBy>
  <cp:revision>3</cp:revision>
  <dcterms:created xsi:type="dcterms:W3CDTF">2022-02-21T15:42:31Z</dcterms:created>
  <dcterms:modified xsi:type="dcterms:W3CDTF">2022-03-01T07:15:47Z</dcterms:modified>
</cp:coreProperties>
</file>